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488" y="-16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尾田 一貴" userId="2c6ceeab09a4e7ce" providerId="LiveId" clId="{8FA8B516-D289-4423-97CC-9B6AB077070A}"/>
    <pc:docChg chg="modSld">
      <pc:chgData name="尾田 一貴" userId="2c6ceeab09a4e7ce" providerId="LiveId" clId="{8FA8B516-D289-4423-97CC-9B6AB077070A}" dt="2021-07-27T10:59:18.845" v="25" actId="6549"/>
      <pc:docMkLst>
        <pc:docMk/>
      </pc:docMkLst>
      <pc:sldChg chg="modSp mod">
        <pc:chgData name="尾田 一貴" userId="2c6ceeab09a4e7ce" providerId="LiveId" clId="{8FA8B516-D289-4423-97CC-9B6AB077070A}" dt="2021-07-27T10:59:18.845" v="25" actId="6549"/>
        <pc:sldMkLst>
          <pc:docMk/>
          <pc:sldMk cId="1857786779" sldId="257"/>
        </pc:sldMkLst>
        <pc:spChg chg="mod">
          <ac:chgData name="尾田 一貴" userId="2c6ceeab09a4e7ce" providerId="LiveId" clId="{8FA8B516-D289-4423-97CC-9B6AB077070A}" dt="2021-07-27T10:59:18.845" v="25" actId="6549"/>
          <ac:spMkLst>
            <pc:docMk/>
            <pc:sldMk cId="1857786779" sldId="257"/>
            <ac:spMk id="4" creationId="{A5E39E3E-8B36-43CC-A843-3E59C289B762}"/>
          </ac:spMkLst>
        </pc:spChg>
      </pc:sldChg>
    </pc:docChg>
  </pc:docChgLst>
  <pc:docChgLst>
    <pc:chgData name="尾田 一貴" userId="2c6ceeab09a4e7ce" providerId="LiveId" clId="{4997845C-E052-41CB-A705-45B080FD64E0}"/>
    <pc:docChg chg="undo redo custSel modSld">
      <pc:chgData name="尾田 一貴" userId="2c6ceeab09a4e7ce" providerId="LiveId" clId="{4997845C-E052-41CB-A705-45B080FD64E0}" dt="2021-07-27T10:06:49.862" v="61" actId="1037"/>
      <pc:docMkLst>
        <pc:docMk/>
      </pc:docMkLst>
      <pc:sldChg chg="delSp modSp mod">
        <pc:chgData name="尾田 一貴" userId="2c6ceeab09a4e7ce" providerId="LiveId" clId="{4997845C-E052-41CB-A705-45B080FD64E0}" dt="2021-07-27T10:06:49.862" v="61" actId="1037"/>
        <pc:sldMkLst>
          <pc:docMk/>
          <pc:sldMk cId="3910890988" sldId="256"/>
        </pc:sldMkLst>
        <pc:spChg chg="del">
          <ac:chgData name="尾田 一貴" userId="2c6ceeab09a4e7ce" providerId="LiveId" clId="{4997845C-E052-41CB-A705-45B080FD64E0}" dt="2021-07-21T10:04:21.090" v="35" actId="478"/>
          <ac:spMkLst>
            <pc:docMk/>
            <pc:sldMk cId="3910890988" sldId="256"/>
            <ac:spMk id="3" creationId="{4B262E26-215C-4AC4-BD44-C01CDA83AAF9}"/>
          </ac:spMkLst>
        </pc:spChg>
        <pc:spChg chg="mod">
          <ac:chgData name="尾田 一貴" userId="2c6ceeab09a4e7ce" providerId="LiveId" clId="{4997845C-E052-41CB-A705-45B080FD64E0}" dt="2021-07-27T10:06:49.862" v="61" actId="1037"/>
          <ac:spMkLst>
            <pc:docMk/>
            <pc:sldMk cId="3910890988" sldId="256"/>
            <ac:spMk id="4" creationId="{DB702C31-EFD0-4611-ACBE-E5CAE1602422}"/>
          </ac:spMkLst>
        </pc:spChg>
        <pc:spChg chg="mod">
          <ac:chgData name="尾田 一貴" userId="2c6ceeab09a4e7ce" providerId="LiveId" clId="{4997845C-E052-41CB-A705-45B080FD64E0}" dt="2021-07-27T10:06:49.862" v="61" actId="1037"/>
          <ac:spMkLst>
            <pc:docMk/>
            <pc:sldMk cId="3910890988" sldId="256"/>
            <ac:spMk id="5" creationId="{68F53BA7-3812-46D4-96F1-F690BB610314}"/>
          </ac:spMkLst>
        </pc:spChg>
        <pc:spChg chg="del">
          <ac:chgData name="尾田 一貴" userId="2c6ceeab09a4e7ce" providerId="LiveId" clId="{4997845C-E052-41CB-A705-45B080FD64E0}" dt="2021-07-21T10:04:21.090" v="35" actId="478"/>
          <ac:spMkLst>
            <pc:docMk/>
            <pc:sldMk cId="3910890988" sldId="256"/>
            <ac:spMk id="7" creationId="{12C9A933-479D-4986-BBEC-1F6910BEB8B1}"/>
          </ac:spMkLst>
        </pc:spChg>
        <pc:spChg chg="mod">
          <ac:chgData name="尾田 一貴" userId="2c6ceeab09a4e7ce" providerId="LiveId" clId="{4997845C-E052-41CB-A705-45B080FD64E0}" dt="2021-07-27T10:06:49.862" v="61" actId="1037"/>
          <ac:spMkLst>
            <pc:docMk/>
            <pc:sldMk cId="3910890988" sldId="256"/>
            <ac:spMk id="10" creationId="{AAABAA31-3CC5-4529-954A-92CD01F79951}"/>
          </ac:spMkLst>
        </pc:spChg>
        <pc:graphicFrameChg chg="mod modGraphic">
          <ac:chgData name="尾田 一貴" userId="2c6ceeab09a4e7ce" providerId="LiveId" clId="{4997845C-E052-41CB-A705-45B080FD64E0}" dt="2021-07-27T10:06:49.862" v="61" actId="1037"/>
          <ac:graphicFrameMkLst>
            <pc:docMk/>
            <pc:sldMk cId="3910890988" sldId="256"/>
            <ac:graphicFrameMk id="6" creationId="{EC2CA764-D550-4B5F-B631-F9098A3AEC8F}"/>
          </ac:graphicFrameMkLst>
        </pc:graphicFrameChg>
        <pc:graphicFrameChg chg="del">
          <ac:chgData name="尾田 一貴" userId="2c6ceeab09a4e7ce" providerId="LiveId" clId="{4997845C-E052-41CB-A705-45B080FD64E0}" dt="2021-07-21T10:04:21.090" v="35" actId="478"/>
          <ac:graphicFrameMkLst>
            <pc:docMk/>
            <pc:sldMk cId="3910890988" sldId="256"/>
            <ac:graphicFrameMk id="8" creationId="{5C13752D-5F3C-46C2-8B61-AF411E1FF788}"/>
          </ac:graphicFrameMkLst>
        </pc:graphicFrameChg>
      </pc:sldChg>
      <pc:sldChg chg="addSp delSp modSp mod">
        <pc:chgData name="尾田 一貴" userId="2c6ceeab09a4e7ce" providerId="LiveId" clId="{4997845C-E052-41CB-A705-45B080FD64E0}" dt="2021-07-19T07:32:09.254" v="34" actId="478"/>
        <pc:sldMkLst>
          <pc:docMk/>
          <pc:sldMk cId="1857786779" sldId="257"/>
        </pc:sldMkLst>
        <pc:spChg chg="mod">
          <ac:chgData name="尾田 一貴" userId="2c6ceeab09a4e7ce" providerId="LiveId" clId="{4997845C-E052-41CB-A705-45B080FD64E0}" dt="2021-07-19T07:14:46.356" v="10" actId="1035"/>
          <ac:spMkLst>
            <pc:docMk/>
            <pc:sldMk cId="1857786779" sldId="257"/>
            <ac:spMk id="4" creationId="{A5E39E3E-8B36-43CC-A843-3E59C289B762}"/>
          </ac:spMkLst>
        </pc:spChg>
        <pc:picChg chg="add del mod ord">
          <ac:chgData name="尾田 一貴" userId="2c6ceeab09a4e7ce" providerId="LiveId" clId="{4997845C-E052-41CB-A705-45B080FD64E0}" dt="2021-07-19T07:32:01.200" v="30" actId="478"/>
          <ac:picMkLst>
            <pc:docMk/>
            <pc:sldMk cId="1857786779" sldId="257"/>
            <ac:picMk id="3" creationId="{1216154D-FD4F-4BE2-AE31-543341928EFB}"/>
          </ac:picMkLst>
        </pc:picChg>
        <pc:picChg chg="add del mod ord">
          <ac:chgData name="尾田 一貴" userId="2c6ceeab09a4e7ce" providerId="LiveId" clId="{4997845C-E052-41CB-A705-45B080FD64E0}" dt="2021-07-19T07:32:09.254" v="34" actId="478"/>
          <ac:picMkLst>
            <pc:docMk/>
            <pc:sldMk cId="1857786779" sldId="257"/>
            <ac:picMk id="6" creationId="{C2DABB15-E411-4A77-BB36-F66CC7F809F4}"/>
          </ac:picMkLst>
        </pc:picChg>
        <pc:picChg chg="add del">
          <ac:chgData name="尾田 一貴" userId="2c6ceeab09a4e7ce" providerId="LiveId" clId="{4997845C-E052-41CB-A705-45B080FD64E0}" dt="2021-07-19T07:32:08.911" v="33" actId="22"/>
          <ac:picMkLst>
            <pc:docMk/>
            <pc:sldMk cId="1857786779" sldId="257"/>
            <ac:picMk id="8" creationId="{9C6F800F-14A3-4F94-9C87-74D45C1D200C}"/>
          </ac:picMkLst>
        </pc:picChg>
        <pc:picChg chg="del">
          <ac:chgData name="尾田 一貴" userId="2c6ceeab09a4e7ce" providerId="LiveId" clId="{4997845C-E052-41CB-A705-45B080FD64E0}" dt="2021-07-19T07:14:37.188" v="2" actId="478"/>
          <ac:picMkLst>
            <pc:docMk/>
            <pc:sldMk cId="1857786779" sldId="257"/>
            <ac:picMk id="11" creationId="{C8058C79-D0CC-4A57-83A6-CA3EA4F1A690}"/>
          </ac:picMkLst>
        </pc:picChg>
      </pc:sldChg>
    </pc:docChg>
  </pc:docChgLst>
  <pc:docChgLst>
    <pc:chgData name="尾田 一貴" userId="2c6ceeab09a4e7ce" providerId="LiveId" clId="{3490B9F9-BDB4-4713-9ACB-E86D3DE41B4C}"/>
    <pc:docChg chg="undo custSel addSld modSld">
      <pc:chgData name="尾田 一貴" userId="2c6ceeab09a4e7ce" providerId="LiveId" clId="{3490B9F9-BDB4-4713-9ACB-E86D3DE41B4C}" dt="2021-07-19T12:05:29.713" v="3117" actId="14100"/>
      <pc:docMkLst>
        <pc:docMk/>
      </pc:docMkLst>
      <pc:sldChg chg="addSp delSp modSp new mod">
        <pc:chgData name="尾田 一貴" userId="2c6ceeab09a4e7ce" providerId="LiveId" clId="{3490B9F9-BDB4-4713-9ACB-E86D3DE41B4C}" dt="2021-07-19T12:05:29.713" v="3117" actId="14100"/>
        <pc:sldMkLst>
          <pc:docMk/>
          <pc:sldMk cId="3910890988" sldId="256"/>
        </pc:sldMkLst>
        <pc:spChg chg="add mod">
          <ac:chgData name="尾田 一貴" userId="2c6ceeab09a4e7ce" providerId="LiveId" clId="{3490B9F9-BDB4-4713-9ACB-E86D3DE41B4C}" dt="2021-07-18T14:08:58.139" v="2114" actId="20577"/>
          <ac:spMkLst>
            <pc:docMk/>
            <pc:sldMk cId="3910890988" sldId="256"/>
            <ac:spMk id="2" creationId="{1D0B6DF4-4622-4184-9A6E-E71B1281D073}"/>
          </ac:spMkLst>
        </pc:spChg>
        <pc:spChg chg="del">
          <ac:chgData name="尾田 一貴" userId="2c6ceeab09a4e7ce" providerId="LiveId" clId="{3490B9F9-BDB4-4713-9ACB-E86D3DE41B4C}" dt="2021-07-16T21:39:22.044" v="1" actId="478"/>
          <ac:spMkLst>
            <pc:docMk/>
            <pc:sldMk cId="3910890988" sldId="256"/>
            <ac:spMk id="2" creationId="{6E8CBC9B-5A8D-437D-9B38-06A38F402BCF}"/>
          </ac:spMkLst>
        </pc:spChg>
        <pc:spChg chg="add mod">
          <ac:chgData name="尾田 一貴" userId="2c6ceeab09a4e7ce" providerId="LiveId" clId="{3490B9F9-BDB4-4713-9ACB-E86D3DE41B4C}" dt="2021-07-19T12:05:29.713" v="3117" actId="14100"/>
          <ac:spMkLst>
            <pc:docMk/>
            <pc:sldMk cId="3910890988" sldId="256"/>
            <ac:spMk id="3" creationId="{4B262E26-215C-4AC4-BD44-C01CDA83AAF9}"/>
          </ac:spMkLst>
        </pc:spChg>
        <pc:spChg chg="del">
          <ac:chgData name="尾田 一貴" userId="2c6ceeab09a4e7ce" providerId="LiveId" clId="{3490B9F9-BDB4-4713-9ACB-E86D3DE41B4C}" dt="2021-07-16T21:39:22.044" v="1" actId="478"/>
          <ac:spMkLst>
            <pc:docMk/>
            <pc:sldMk cId="3910890988" sldId="256"/>
            <ac:spMk id="3" creationId="{B4736C62-A6EE-4E96-8D73-F809A62E3DA6}"/>
          </ac:spMkLst>
        </pc:spChg>
        <pc:spChg chg="add mod">
          <ac:chgData name="尾田 一貴" userId="2c6ceeab09a4e7ce" providerId="LiveId" clId="{3490B9F9-BDB4-4713-9ACB-E86D3DE41B4C}" dt="2021-07-18T14:04:29.762" v="2054" actId="1076"/>
          <ac:spMkLst>
            <pc:docMk/>
            <pc:sldMk cId="3910890988" sldId="256"/>
            <ac:spMk id="4" creationId="{DB702C31-EFD0-4611-ACBE-E5CAE1602422}"/>
          </ac:spMkLst>
        </pc:spChg>
        <pc:spChg chg="add mod">
          <ac:chgData name="尾田 一貴" userId="2c6ceeab09a4e7ce" providerId="LiveId" clId="{3490B9F9-BDB4-4713-9ACB-E86D3DE41B4C}" dt="2021-07-16T21:57:07.852" v="841" actId="1076"/>
          <ac:spMkLst>
            <pc:docMk/>
            <pc:sldMk cId="3910890988" sldId="256"/>
            <ac:spMk id="5" creationId="{68F53BA7-3812-46D4-96F1-F690BB610314}"/>
          </ac:spMkLst>
        </pc:spChg>
        <pc:spChg chg="add mod">
          <ac:chgData name="尾田 一貴" userId="2c6ceeab09a4e7ce" providerId="LiveId" clId="{3490B9F9-BDB4-4713-9ACB-E86D3DE41B4C}" dt="2021-07-18T21:17:54.957" v="2808" actId="20577"/>
          <ac:spMkLst>
            <pc:docMk/>
            <pc:sldMk cId="3910890988" sldId="256"/>
            <ac:spMk id="7" creationId="{12C9A933-479D-4986-BBEC-1F6910BEB8B1}"/>
          </ac:spMkLst>
        </pc:spChg>
        <pc:spChg chg="add del mod">
          <ac:chgData name="尾田 一貴" userId="2c6ceeab09a4e7ce" providerId="LiveId" clId="{3490B9F9-BDB4-4713-9ACB-E86D3DE41B4C}" dt="2021-07-16T21:51:45.839" v="580"/>
          <ac:spMkLst>
            <pc:docMk/>
            <pc:sldMk cId="3910890988" sldId="256"/>
            <ac:spMk id="9" creationId="{E5FF855A-BA78-47AF-BDE7-ED6E61B0AE73}"/>
          </ac:spMkLst>
        </pc:spChg>
        <pc:spChg chg="add mod">
          <ac:chgData name="尾田 一貴" userId="2c6ceeab09a4e7ce" providerId="LiveId" clId="{3490B9F9-BDB4-4713-9ACB-E86D3DE41B4C}" dt="2021-07-19T11:58:13.625" v="3107" actId="13926"/>
          <ac:spMkLst>
            <pc:docMk/>
            <pc:sldMk cId="3910890988" sldId="256"/>
            <ac:spMk id="10" creationId="{AAABAA31-3CC5-4529-954A-92CD01F79951}"/>
          </ac:spMkLst>
        </pc:spChg>
        <pc:spChg chg="add mod">
          <ac:chgData name="尾田 一貴" userId="2c6ceeab09a4e7ce" providerId="LiveId" clId="{3490B9F9-BDB4-4713-9ACB-E86D3DE41B4C}" dt="2021-07-18T13:59:46.887" v="1625" actId="1035"/>
          <ac:spMkLst>
            <pc:docMk/>
            <pc:sldMk cId="3910890988" sldId="256"/>
            <ac:spMk id="14" creationId="{7FD551E2-4E20-4C0A-B95B-6E0F5678AF75}"/>
          </ac:spMkLst>
        </pc:spChg>
        <pc:spChg chg="add mod">
          <ac:chgData name="尾田 一貴" userId="2c6ceeab09a4e7ce" providerId="LiveId" clId="{3490B9F9-BDB4-4713-9ACB-E86D3DE41B4C}" dt="2021-07-18T13:59:44.276" v="1620" actId="1036"/>
          <ac:spMkLst>
            <pc:docMk/>
            <pc:sldMk cId="3910890988" sldId="256"/>
            <ac:spMk id="15" creationId="{9365DAB3-CB71-4E78-AE81-A8F10F9C5F92}"/>
          </ac:spMkLst>
        </pc:spChg>
        <pc:spChg chg="add mod">
          <ac:chgData name="尾田 一貴" userId="2c6ceeab09a4e7ce" providerId="LiveId" clId="{3490B9F9-BDB4-4713-9ACB-E86D3DE41B4C}" dt="2021-07-18T13:59:28.123" v="1600" actId="1076"/>
          <ac:spMkLst>
            <pc:docMk/>
            <pc:sldMk cId="3910890988" sldId="256"/>
            <ac:spMk id="16" creationId="{E8AE5F6B-95E6-4EB5-8F1A-90D8705C57EA}"/>
          </ac:spMkLst>
        </pc:spChg>
        <pc:spChg chg="add mod">
          <ac:chgData name="尾田 一貴" userId="2c6ceeab09a4e7ce" providerId="LiveId" clId="{3490B9F9-BDB4-4713-9ACB-E86D3DE41B4C}" dt="2021-07-18T13:59:40.300" v="1615" actId="1035"/>
          <ac:spMkLst>
            <pc:docMk/>
            <pc:sldMk cId="3910890988" sldId="256"/>
            <ac:spMk id="17" creationId="{60F8AC9C-28C3-4311-B3F3-72F419EAAD5D}"/>
          </ac:spMkLst>
        </pc:spChg>
        <pc:graphicFrameChg chg="add mod modGraphic">
          <ac:chgData name="尾田 一貴" userId="2c6ceeab09a4e7ce" providerId="LiveId" clId="{3490B9F9-BDB4-4713-9ACB-E86D3DE41B4C}" dt="2021-07-19T11:57:08.028" v="3073" actId="20577"/>
          <ac:graphicFrameMkLst>
            <pc:docMk/>
            <pc:sldMk cId="3910890988" sldId="256"/>
            <ac:graphicFrameMk id="6" creationId="{EC2CA764-D550-4B5F-B631-F9098A3AEC8F}"/>
          </ac:graphicFrameMkLst>
        </pc:graphicFrameChg>
        <pc:graphicFrameChg chg="add mod modGraphic">
          <ac:chgData name="尾田 一貴" userId="2c6ceeab09a4e7ce" providerId="LiveId" clId="{3490B9F9-BDB4-4713-9ACB-E86D3DE41B4C}" dt="2021-07-18T14:12:07.683" v="2196" actId="207"/>
          <ac:graphicFrameMkLst>
            <pc:docMk/>
            <pc:sldMk cId="3910890988" sldId="256"/>
            <ac:graphicFrameMk id="8" creationId="{5C13752D-5F3C-46C2-8B61-AF411E1FF788}"/>
          </ac:graphicFrameMkLst>
        </pc:graphicFrameChg>
        <pc:picChg chg="add del mod">
          <ac:chgData name="尾田 一貴" userId="2c6ceeab09a4e7ce" providerId="LiveId" clId="{3490B9F9-BDB4-4713-9ACB-E86D3DE41B4C}" dt="2021-07-16T22:00:42.407" v="906" actId="478"/>
          <ac:picMkLst>
            <pc:docMk/>
            <pc:sldMk cId="3910890988" sldId="256"/>
            <ac:picMk id="12" creationId="{D5E3F294-CF6B-409E-B7BC-F5751F939C32}"/>
          </ac:picMkLst>
        </pc:picChg>
        <pc:cxnChg chg="add mod">
          <ac:chgData name="尾田 一貴" userId="2c6ceeab09a4e7ce" providerId="LiveId" clId="{3490B9F9-BDB4-4713-9ACB-E86D3DE41B4C}" dt="2021-07-18T13:58:24.564" v="1542" actId="208"/>
          <ac:cxnSpMkLst>
            <pc:docMk/>
            <pc:sldMk cId="3910890988" sldId="256"/>
            <ac:cxnSpMk id="9" creationId="{180F00BF-54CC-4885-A39F-E67B319EA8F4}"/>
          </ac:cxnSpMkLst>
        </pc:cxnChg>
        <pc:cxnChg chg="add mod">
          <ac:chgData name="尾田 一貴" userId="2c6ceeab09a4e7ce" providerId="LiveId" clId="{3490B9F9-BDB4-4713-9ACB-E86D3DE41B4C}" dt="2021-07-18T13:58:33.251" v="1544" actId="1076"/>
          <ac:cxnSpMkLst>
            <pc:docMk/>
            <pc:sldMk cId="3910890988" sldId="256"/>
            <ac:cxnSpMk id="11" creationId="{BB2A71EC-2BE2-49C2-8DDB-69AC909F6ECA}"/>
          </ac:cxnSpMkLst>
        </pc:cxnChg>
        <pc:cxnChg chg="add mod">
          <ac:chgData name="尾田 一貴" userId="2c6ceeab09a4e7ce" providerId="LiveId" clId="{3490B9F9-BDB4-4713-9ACB-E86D3DE41B4C}" dt="2021-07-18T13:58:36.956" v="1546" actId="1076"/>
          <ac:cxnSpMkLst>
            <pc:docMk/>
            <pc:sldMk cId="3910890988" sldId="256"/>
            <ac:cxnSpMk id="12" creationId="{DF64D485-125F-4641-A490-C2DE3E53EC6F}"/>
          </ac:cxnSpMkLst>
        </pc:cxnChg>
        <pc:cxnChg chg="add mod">
          <ac:chgData name="尾田 一貴" userId="2c6ceeab09a4e7ce" providerId="LiveId" clId="{3490B9F9-BDB4-4713-9ACB-E86D3DE41B4C}" dt="2021-07-18T13:58:40.309" v="1548" actId="1076"/>
          <ac:cxnSpMkLst>
            <pc:docMk/>
            <pc:sldMk cId="3910890988" sldId="256"/>
            <ac:cxnSpMk id="13" creationId="{82ACD095-51B5-4B51-B33E-A0CFB4DC5791}"/>
          </ac:cxnSpMkLst>
        </pc:cxnChg>
      </pc:sldChg>
      <pc:sldChg chg="addSp delSp modSp new mod">
        <pc:chgData name="尾田 一貴" userId="2c6ceeab09a4e7ce" providerId="LiveId" clId="{3490B9F9-BDB4-4713-9ACB-E86D3DE41B4C}" dt="2021-07-18T14:24:06.258" v="2787" actId="20577"/>
        <pc:sldMkLst>
          <pc:docMk/>
          <pc:sldMk cId="1857786779" sldId="257"/>
        </pc:sldMkLst>
        <pc:spChg chg="del">
          <ac:chgData name="尾田 一貴" userId="2c6ceeab09a4e7ce" providerId="LiveId" clId="{3490B9F9-BDB4-4713-9ACB-E86D3DE41B4C}" dt="2021-07-16T22:00:35.557" v="903" actId="478"/>
          <ac:spMkLst>
            <pc:docMk/>
            <pc:sldMk cId="1857786779" sldId="257"/>
            <ac:spMk id="2" creationId="{46F0B0E5-4DF6-47A2-8111-15655030E14D}"/>
          </ac:spMkLst>
        </pc:spChg>
        <pc:spChg chg="del">
          <ac:chgData name="尾田 一貴" userId="2c6ceeab09a4e7ce" providerId="LiveId" clId="{3490B9F9-BDB4-4713-9ACB-E86D3DE41B4C}" dt="2021-07-16T22:00:35.557" v="903" actId="478"/>
          <ac:spMkLst>
            <pc:docMk/>
            <pc:sldMk cId="1857786779" sldId="257"/>
            <ac:spMk id="3" creationId="{8BD0456D-4140-4CCC-A572-40A22643A5DE}"/>
          </ac:spMkLst>
        </pc:spChg>
        <pc:spChg chg="add mod">
          <ac:chgData name="尾田 一貴" userId="2c6ceeab09a4e7ce" providerId="LiveId" clId="{3490B9F9-BDB4-4713-9ACB-E86D3DE41B4C}" dt="2021-07-18T14:24:06.258" v="2787" actId="20577"/>
          <ac:spMkLst>
            <pc:docMk/>
            <pc:sldMk cId="1857786779" sldId="257"/>
            <ac:spMk id="4" creationId="{A5E39E3E-8B36-43CC-A843-3E59C289B762}"/>
          </ac:spMkLst>
        </pc:spChg>
        <pc:picChg chg="add del">
          <ac:chgData name="尾田 一貴" userId="2c6ceeab09a4e7ce" providerId="LiveId" clId="{3490B9F9-BDB4-4713-9ACB-E86D3DE41B4C}" dt="2021-07-18T12:39:33.469" v="1022" actId="22"/>
          <ac:picMkLst>
            <pc:docMk/>
            <pc:sldMk cId="1857786779" sldId="257"/>
            <ac:picMk id="3" creationId="{4872C297-CF20-4EA7-A5BA-8BAD50295428}"/>
          </ac:picMkLst>
        </pc:picChg>
        <pc:picChg chg="add del mod">
          <ac:chgData name="尾田 一貴" userId="2c6ceeab09a4e7ce" providerId="LiveId" clId="{3490B9F9-BDB4-4713-9ACB-E86D3DE41B4C}" dt="2021-07-17T00:27:01.062" v="1017" actId="478"/>
          <ac:picMkLst>
            <pc:docMk/>
            <pc:sldMk cId="1857786779" sldId="257"/>
            <ac:picMk id="5" creationId="{3002BAD0-5F5B-4CBE-9B0D-B2897D7CA82B}"/>
          </ac:picMkLst>
        </pc:picChg>
        <pc:picChg chg="add del">
          <ac:chgData name="尾田 一貴" userId="2c6ceeab09a4e7ce" providerId="LiveId" clId="{3490B9F9-BDB4-4713-9ACB-E86D3DE41B4C}" dt="2021-07-18T12:39:45.648" v="1024" actId="22"/>
          <ac:picMkLst>
            <pc:docMk/>
            <pc:sldMk cId="1857786779" sldId="257"/>
            <ac:picMk id="6" creationId="{52936455-BD10-467A-968F-FB88A0828723}"/>
          </ac:picMkLst>
        </pc:picChg>
        <pc:picChg chg="add del mod">
          <ac:chgData name="尾田 一貴" userId="2c6ceeab09a4e7ce" providerId="LiveId" clId="{3490B9F9-BDB4-4713-9ACB-E86D3DE41B4C}" dt="2021-07-18T12:39:59.029" v="1026" actId="478"/>
          <ac:picMkLst>
            <pc:docMk/>
            <pc:sldMk cId="1857786779" sldId="257"/>
            <ac:picMk id="7" creationId="{047E4AC7-638C-424D-BBC9-64B7FE90FD9E}"/>
          </ac:picMkLst>
        </pc:picChg>
        <pc:picChg chg="add del mod ord">
          <ac:chgData name="尾田 一貴" userId="2c6ceeab09a4e7ce" providerId="LiveId" clId="{3490B9F9-BDB4-4713-9ACB-E86D3DE41B4C}" dt="2021-07-18T12:50:47.801" v="1031" actId="478"/>
          <ac:picMkLst>
            <pc:docMk/>
            <pc:sldMk cId="1857786779" sldId="257"/>
            <ac:picMk id="9" creationId="{9F903025-446D-43BF-9D7B-979F4208E8C9}"/>
          </ac:picMkLst>
        </pc:picChg>
        <pc:picChg chg="add mod">
          <ac:chgData name="尾田 一貴" userId="2c6ceeab09a4e7ce" providerId="LiveId" clId="{3490B9F9-BDB4-4713-9ACB-E86D3DE41B4C}" dt="2021-07-18T12:50:49.169" v="1032" actId="1076"/>
          <ac:picMkLst>
            <pc:docMk/>
            <pc:sldMk cId="1857786779" sldId="257"/>
            <ac:picMk id="11" creationId="{C8058C79-D0CC-4A57-83A6-CA3EA4F1A690}"/>
          </ac:picMkLst>
        </pc:picChg>
      </pc:sldChg>
    </pc:docChg>
  </pc:docChgLst>
  <pc:docChgLst>
    <pc:chgData name="尾田 一貴" userId="2c6ceeab09a4e7ce" providerId="LiveId" clId="{03C1FB79-EE92-4325-98A9-D15E5A85E2C2}"/>
    <pc:docChg chg="modSld">
      <pc:chgData name="尾田 一貴" userId="2c6ceeab09a4e7ce" providerId="LiveId" clId="{03C1FB79-EE92-4325-98A9-D15E5A85E2C2}" dt="2021-08-01T14:50:15.867" v="1" actId="14100"/>
      <pc:docMkLst>
        <pc:docMk/>
      </pc:docMkLst>
      <pc:sldChg chg="modSp mod">
        <pc:chgData name="尾田 一貴" userId="2c6ceeab09a4e7ce" providerId="LiveId" clId="{03C1FB79-EE92-4325-98A9-D15E5A85E2C2}" dt="2021-08-01T14:50:15.867" v="1" actId="14100"/>
        <pc:sldMkLst>
          <pc:docMk/>
          <pc:sldMk cId="1857786779" sldId="257"/>
        </pc:sldMkLst>
        <pc:spChg chg="mod">
          <ac:chgData name="尾田 一貴" userId="2c6ceeab09a4e7ce" providerId="LiveId" clId="{03C1FB79-EE92-4325-98A9-D15E5A85E2C2}" dt="2021-08-01T14:50:15.867" v="1" actId="14100"/>
          <ac:spMkLst>
            <pc:docMk/>
            <pc:sldMk cId="1857786779" sldId="257"/>
            <ac:spMk id="4" creationId="{A5E39E3E-8B36-43CC-A843-3E59C289B76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403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51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499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6977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929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3716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176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342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1589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075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56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DC91C-D54F-4497-A2E2-C2681A2736CE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C8CD6-2AD7-4845-B1CF-35203BF4DC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600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B702C31-EFD0-4611-ACBE-E5CAE1602422}"/>
              </a:ext>
            </a:extLst>
          </p:cNvPr>
          <p:cNvSpPr txBox="1"/>
          <p:nvPr/>
        </p:nvSpPr>
        <p:spPr>
          <a:xfrm>
            <a:off x="76614" y="3504420"/>
            <a:ext cx="67845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Sample preparation flow through solid phase extraction method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Prepared sample volumes for the standard filter and dilute methods are 15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30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8F53BA7-3812-46D4-96F1-F690BB610314}"/>
              </a:ext>
            </a:extLst>
          </p:cNvPr>
          <p:cNvSpPr txBox="1"/>
          <p:nvPr/>
        </p:nvSpPr>
        <p:spPr>
          <a:xfrm>
            <a:off x="76614" y="5105245"/>
            <a:ext cx="53728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. S1. Validation result for the measurement of voriconazole using LM1010.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6">
            <a:extLst>
              <a:ext uri="{FF2B5EF4-FFF2-40B4-BE49-F238E27FC236}">
                <a16:creationId xmlns:a16="http://schemas.microsoft.com/office/drawing/2014/main" id="{EC2CA764-D550-4B5F-B631-F9098A3AEC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7850016"/>
              </p:ext>
            </p:extLst>
          </p:nvPr>
        </p:nvGraphicFramePr>
        <p:xfrm>
          <a:off x="173663" y="5393789"/>
          <a:ext cx="4348734" cy="1569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8164">
                  <a:extLst>
                    <a:ext uri="{9D8B030D-6E8A-4147-A177-3AD203B41FA5}">
                      <a16:colId xmlns:a16="http://schemas.microsoft.com/office/drawing/2014/main" val="1854702748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046538840"/>
                    </a:ext>
                  </a:extLst>
                </a:gridCol>
                <a:gridCol w="1437005">
                  <a:extLst>
                    <a:ext uri="{9D8B030D-6E8A-4147-A177-3AD203B41FA5}">
                      <a16:colId xmlns:a16="http://schemas.microsoft.com/office/drawing/2014/main" val="1667258788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223258297"/>
                    </a:ext>
                  </a:extLst>
                </a:gridCol>
                <a:gridCol w="1437005">
                  <a:extLst>
                    <a:ext uri="{9D8B030D-6E8A-4147-A177-3AD203B41FA5}">
                      <a16:colId xmlns:a16="http://schemas.microsoft.com/office/drawing/2014/main" val="232989355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, μg/mL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uracy</a:t>
                      </a:r>
                    </a:p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5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-day variability</a:t>
                      </a:r>
                    </a:p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5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15761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6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22070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8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47133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2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%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2524568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AABAA31-3CC5-4529-954A-92CD01F79951}"/>
              </a:ext>
            </a:extLst>
          </p:cNvPr>
          <p:cNvSpPr txBox="1"/>
          <p:nvPr/>
        </p:nvSpPr>
        <p:spPr>
          <a:xfrm>
            <a:off x="76614" y="6987823"/>
            <a:ext cx="5457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ibration curve range were 1–5 μg/mL in which R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 was 0.99812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D0B6DF4-4622-4184-9A6E-E71B1281D073}"/>
              </a:ext>
            </a:extLst>
          </p:cNvPr>
          <p:cNvSpPr txBox="1"/>
          <p:nvPr/>
        </p:nvSpPr>
        <p:spPr>
          <a:xfrm>
            <a:off x="1198031" y="126749"/>
            <a:ext cx="4174091" cy="33504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Apply pretreatment solution A (50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to the spin column.</a:t>
            </a:r>
          </a:p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centrifuga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400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1 min</a:t>
            </a:r>
          </a:p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Apply pretreatment solution B  (50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to the spin column</a:t>
            </a:r>
          </a:p>
          <a:p>
            <a:pPr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centrifuga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400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1 min</a:t>
            </a:r>
          </a:p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Apply prepared sample 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to the spin column</a:t>
            </a:r>
          </a:p>
          <a:p>
            <a:pPr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centrifuga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400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3 min</a:t>
            </a:r>
          </a:p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Apply pretreatment solution B (50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to the spin column</a:t>
            </a:r>
          </a:p>
          <a:p>
            <a:pPr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	centrifuga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400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2 min</a:t>
            </a:r>
          </a:p>
          <a:p>
            <a:pPr algn="l">
              <a:lnSpc>
                <a:spcPts val="27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 Apply pretreatment solution C (15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 the spin column</a:t>
            </a:r>
          </a:p>
          <a:p>
            <a:pPr algn="l">
              <a:lnSpc>
                <a:spcPts val="1100"/>
              </a:lnSpc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Eluted samples were further mixed by flicking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180F00BF-54CC-4885-A39F-E67B319EA8F4}"/>
              </a:ext>
            </a:extLst>
          </p:cNvPr>
          <p:cNvCxnSpPr/>
          <p:nvPr/>
        </p:nvCxnSpPr>
        <p:spPr>
          <a:xfrm>
            <a:off x="2072640" y="50292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BB2A71EC-2BE2-49C2-8DDB-69AC909F6ECA}"/>
              </a:ext>
            </a:extLst>
          </p:cNvPr>
          <p:cNvCxnSpPr/>
          <p:nvPr/>
        </p:nvCxnSpPr>
        <p:spPr>
          <a:xfrm>
            <a:off x="2072640" y="118872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DF64D485-125F-4641-A490-C2DE3E53EC6F}"/>
              </a:ext>
            </a:extLst>
          </p:cNvPr>
          <p:cNvCxnSpPr/>
          <p:nvPr/>
        </p:nvCxnSpPr>
        <p:spPr>
          <a:xfrm>
            <a:off x="2072640" y="187452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82ACD095-51B5-4B51-B33E-A0CFB4DC5791}"/>
              </a:ext>
            </a:extLst>
          </p:cNvPr>
          <p:cNvCxnSpPr/>
          <p:nvPr/>
        </p:nvCxnSpPr>
        <p:spPr>
          <a:xfrm>
            <a:off x="2072640" y="2552700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FD551E2-4E20-4C0A-B95B-6E0F5678AF75}"/>
              </a:ext>
            </a:extLst>
          </p:cNvPr>
          <p:cNvSpPr txBox="1"/>
          <p:nvPr/>
        </p:nvSpPr>
        <p:spPr>
          <a:xfrm rot="10800000">
            <a:off x="828700" y="265065"/>
            <a:ext cx="369332" cy="90665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ing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365DAB3-CB71-4E78-AE81-A8F10F9C5F92}"/>
              </a:ext>
            </a:extLst>
          </p:cNvPr>
          <p:cNvSpPr txBox="1"/>
          <p:nvPr/>
        </p:nvSpPr>
        <p:spPr>
          <a:xfrm rot="10800000">
            <a:off x="828699" y="1361978"/>
            <a:ext cx="369332" cy="78483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sorptio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8AE5F6B-95E6-4EB5-8F1A-90D8705C57EA}"/>
              </a:ext>
            </a:extLst>
          </p:cNvPr>
          <p:cNvSpPr txBox="1"/>
          <p:nvPr/>
        </p:nvSpPr>
        <p:spPr>
          <a:xfrm rot="10800000">
            <a:off x="830390" y="2223588"/>
            <a:ext cx="369332" cy="431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h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0F8AC9C-28C3-4311-B3F3-72F419EAAD5D}"/>
              </a:ext>
            </a:extLst>
          </p:cNvPr>
          <p:cNvSpPr txBox="1"/>
          <p:nvPr/>
        </p:nvSpPr>
        <p:spPr>
          <a:xfrm rot="10800000">
            <a:off x="828699" y="2864141"/>
            <a:ext cx="369332" cy="5475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utio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0890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C2DABB15-E411-4A77-BB36-F66CC7F809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5E39E3E-8B36-43CC-A843-3E59C289B762}"/>
              </a:ext>
            </a:extLst>
          </p:cNvPr>
          <p:cNvSpPr txBox="1"/>
          <p:nvPr/>
        </p:nvSpPr>
        <p:spPr>
          <a:xfrm>
            <a:off x="0" y="6641122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Bland-Altman analysis for assessment of systematic errors on measurement methods.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 of the one pair measurement (all vertical axes) was calculated by a measured value of LM1010 – that of outsourcing. Mean of the one pair measurement (horizontal axes of a, b) was calculated by (a measured value of LM1010 – that of outsourcing)/2. During time from sampling to measurement (horizontal axes of c, d), samples were completely stored at -80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deep freezer.</a:t>
            </a:r>
          </a:p>
        </p:txBody>
      </p:sp>
    </p:spTree>
    <p:extLst>
      <p:ext uri="{BB962C8B-B14F-4D97-AF65-F5344CB8AC3E}">
        <p14:creationId xmlns:p14="http://schemas.microsoft.com/office/powerpoint/2010/main" val="1857786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200" b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</TotalTime>
  <Words>303</Words>
  <Application>Microsoft Office PowerPoint</Application>
  <PresentationFormat>A4 210 x 297 mm</PresentationFormat>
  <Paragraphs>3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尾田 一貴</dc:creator>
  <cp:lastModifiedBy>尾田 一貴</cp:lastModifiedBy>
  <cp:revision>9</cp:revision>
  <dcterms:created xsi:type="dcterms:W3CDTF">2021-07-16T21:39:18Z</dcterms:created>
  <dcterms:modified xsi:type="dcterms:W3CDTF">2021-08-01T14:50:34Z</dcterms:modified>
</cp:coreProperties>
</file>